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9453AE3-C8D2-45FE-8AB7-072B88C85B8B}" v="4" dt="2020-02-24T07:12:49.61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15" autoAdjust="0"/>
    <p:restoredTop sz="94660"/>
  </p:normalViewPr>
  <p:slideViewPr>
    <p:cSldViewPr snapToGrid="0" showGuides="1">
      <p:cViewPr varScale="1">
        <p:scale>
          <a:sx n="70" d="100"/>
          <a:sy n="70" d="100"/>
        </p:scale>
        <p:origin x="1314" y="7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nn Meyers" userId="470a02ee-1e65-42af-a6dc-85a5b9f23514" providerId="ADAL" clId="{79453AE3-C8D2-45FE-8AB7-072B88C85B8B}"/>
    <pc:docChg chg="modSld">
      <pc:chgData name="Ann Meyers" userId="470a02ee-1e65-42af-a6dc-85a5b9f23514" providerId="ADAL" clId="{79453AE3-C8D2-45FE-8AB7-072B88C85B8B}" dt="2020-02-24T07:12:49.616" v="21" actId="207"/>
      <pc:docMkLst>
        <pc:docMk/>
      </pc:docMkLst>
      <pc:sldChg chg="addSp modSp">
        <pc:chgData name="Ann Meyers" userId="470a02ee-1e65-42af-a6dc-85a5b9f23514" providerId="ADAL" clId="{79453AE3-C8D2-45FE-8AB7-072B88C85B8B}" dt="2020-02-24T07:12:49.616" v="21" actId="207"/>
        <pc:sldMkLst>
          <pc:docMk/>
          <pc:sldMk cId="2838613965" sldId="256"/>
        </pc:sldMkLst>
        <pc:spChg chg="add mod">
          <ac:chgData name="Ann Meyers" userId="470a02ee-1e65-42af-a6dc-85a5b9f23514" providerId="ADAL" clId="{79453AE3-C8D2-45FE-8AB7-072B88C85B8B}" dt="2020-02-24T07:12:49.616" v="21" actId="207"/>
          <ac:spMkLst>
            <pc:docMk/>
            <pc:sldMk cId="2838613965" sldId="256"/>
            <ac:spMk id="2" creationId="{29B4200E-88FA-478E-AF57-D1FB60C0E2C8}"/>
          </ac:spMkLst>
        </pc:spChg>
        <pc:picChg chg="mod">
          <ac:chgData name="Ann Meyers" userId="470a02ee-1e65-42af-a6dc-85a5b9f23514" providerId="ADAL" clId="{79453AE3-C8D2-45FE-8AB7-072B88C85B8B}" dt="2020-02-03T11:00:36.473" v="0" actId="1076"/>
          <ac:picMkLst>
            <pc:docMk/>
            <pc:sldMk cId="2838613965" sldId="256"/>
            <ac:picMk id="4" creationId="{FAE20C0F-A497-4651-BF57-E4F7831E2721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2C94D-3431-410F-9D7D-5231B9630D2D}" type="datetimeFigureOut">
              <a:rPr lang="en-ZA" smtClean="0"/>
              <a:t>2020/02/24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A2C7A-D339-41A6-9CDB-892F50EB100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7559225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2C94D-3431-410F-9D7D-5231B9630D2D}" type="datetimeFigureOut">
              <a:rPr lang="en-ZA" smtClean="0"/>
              <a:t>2020/02/24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A2C7A-D339-41A6-9CDB-892F50EB100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4584144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2C94D-3431-410F-9D7D-5231B9630D2D}" type="datetimeFigureOut">
              <a:rPr lang="en-ZA" smtClean="0"/>
              <a:t>2020/02/24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A2C7A-D339-41A6-9CDB-892F50EB100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1378941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2C94D-3431-410F-9D7D-5231B9630D2D}" type="datetimeFigureOut">
              <a:rPr lang="en-ZA" smtClean="0"/>
              <a:t>2020/02/24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A2C7A-D339-41A6-9CDB-892F50EB100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3165130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2C94D-3431-410F-9D7D-5231B9630D2D}" type="datetimeFigureOut">
              <a:rPr lang="en-ZA" smtClean="0"/>
              <a:t>2020/02/24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A2C7A-D339-41A6-9CDB-892F50EB100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7743682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2C94D-3431-410F-9D7D-5231B9630D2D}" type="datetimeFigureOut">
              <a:rPr lang="en-ZA" smtClean="0"/>
              <a:t>2020/02/24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A2C7A-D339-41A6-9CDB-892F50EB100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3781249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2C94D-3431-410F-9D7D-5231B9630D2D}" type="datetimeFigureOut">
              <a:rPr lang="en-ZA" smtClean="0"/>
              <a:t>2020/02/24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A2C7A-D339-41A6-9CDB-892F50EB100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2634070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2C94D-3431-410F-9D7D-5231B9630D2D}" type="datetimeFigureOut">
              <a:rPr lang="en-ZA" smtClean="0"/>
              <a:t>2020/02/24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A2C7A-D339-41A6-9CDB-892F50EB100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909098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2C94D-3431-410F-9D7D-5231B9630D2D}" type="datetimeFigureOut">
              <a:rPr lang="en-ZA" smtClean="0"/>
              <a:t>2020/02/24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A2C7A-D339-41A6-9CDB-892F50EB100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7089903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2C94D-3431-410F-9D7D-5231B9630D2D}" type="datetimeFigureOut">
              <a:rPr lang="en-ZA" smtClean="0"/>
              <a:t>2020/02/24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A2C7A-D339-41A6-9CDB-892F50EB100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0289743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2C94D-3431-410F-9D7D-5231B9630D2D}" type="datetimeFigureOut">
              <a:rPr lang="en-ZA" smtClean="0"/>
              <a:t>2020/02/24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A2C7A-D339-41A6-9CDB-892F50EB100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2354522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82C94D-3431-410F-9D7D-5231B9630D2D}" type="datetimeFigureOut">
              <a:rPr lang="en-ZA" smtClean="0"/>
              <a:t>2020/02/24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9A2C7A-D339-41A6-9CDB-892F50EB100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7067247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AE20C0F-A497-4651-BF57-E4F7831E272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552791"/>
            <a:ext cx="6858000" cy="5209725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29B4200E-88FA-478E-AF57-D1FB60C0E2C8}"/>
              </a:ext>
            </a:extLst>
          </p:cNvPr>
          <p:cNvSpPr/>
          <p:nvPr/>
        </p:nvSpPr>
        <p:spPr>
          <a:xfrm>
            <a:off x="579863" y="6137856"/>
            <a:ext cx="5698273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-expression of human calnexin and calreticulin with influenza HA and </a:t>
            </a:r>
            <a:r>
              <a:rPr lang="en-ZA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ngue virus</a:t>
            </a:r>
            <a:r>
              <a:rPr lang="en-ZA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ME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qual volumes of total soluble protein were resolved by SDS-PAGE. Recombinant HA and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nV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ME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re detected using polyclonal rabbit anti-HA and anti-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nV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. Influenza H1 hemagglutinin (HA), calnexin (CNX), calreticulin (CRT). The red asterisks refer to the 2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nV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 protein products that were detected following western blotting (* and **). (MW= molecular weight marker, HA = HA expression only, HA/CRT = HA and CRT co-expression, HA/CNX = HA and CNX co-expression,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nV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nV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 only,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nV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CNX =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nV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CNX co-expression,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nV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CRT =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nv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CRT co-expression).</a:t>
            </a:r>
            <a:endParaRPr lang="en-ZA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386139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3FA2F3BAF291F44B9BAC9868B50C80F1" ma:contentTypeVersion="13" ma:contentTypeDescription="Create a new document." ma:contentTypeScope="" ma:versionID="bc4a9a0540e0ef972c7ebd2a0284d042">
  <xsd:schema xmlns:xsd="http://www.w3.org/2001/XMLSchema" xmlns:xs="http://www.w3.org/2001/XMLSchema" xmlns:p="http://schemas.microsoft.com/office/2006/metadata/properties" xmlns:ns3="dcca6e4b-f4d1-4c2f-83f7-8a9b9cca29ae" xmlns:ns4="220f49fd-4060-4647-a9a5-4c9032b44770" targetNamespace="http://schemas.microsoft.com/office/2006/metadata/properties" ma:root="true" ma:fieldsID="875b4c7d21ae34cbc3f1277f276c462c" ns3:_="" ns4:_="">
    <xsd:import namespace="dcca6e4b-f4d1-4c2f-83f7-8a9b9cca29ae"/>
    <xsd:import namespace="220f49fd-4060-4647-a9a5-4c9032b44770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cca6e4b-f4d1-4c2f-83f7-8a9b9cca29a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1" nillable="true" ma:displayName="Tags" ma:internalName="MediaServiceAutoTags" ma:readOnly="true">
      <xsd:simpleType>
        <xsd:restriction base="dms:Text"/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5" nillable="true" ma:displayName="Location" ma:internalName="MediaServiceLocation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20f49fd-4060-4647-a9a5-4c9032b44770" elementFormDefault="qualified">
    <xsd:import namespace="http://schemas.microsoft.com/office/2006/documentManagement/types"/>
    <xsd:import namespace="http://schemas.microsoft.com/office/infopath/2007/PartnerControls"/>
    <xsd:element name="SharedWithUsers" ma:index="16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7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8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5A347F9A-70E9-47A7-A045-F7E9952FF3F9}">
  <ds:schemaRefs>
    <ds:schemaRef ds:uri="http://purl.org/dc/terms/"/>
    <ds:schemaRef ds:uri="http://schemas.openxmlformats.org/package/2006/metadata/core-properties"/>
    <ds:schemaRef ds:uri="http://schemas.microsoft.com/office/2006/documentManagement/types"/>
    <ds:schemaRef ds:uri="http://schemas.microsoft.com/office/infopath/2007/PartnerControls"/>
    <ds:schemaRef ds:uri="http://purl.org/dc/elements/1.1/"/>
    <ds:schemaRef ds:uri="http://schemas.microsoft.com/office/2006/metadata/properties"/>
    <ds:schemaRef ds:uri="220f49fd-4060-4647-a9a5-4c9032b44770"/>
    <ds:schemaRef ds:uri="dcca6e4b-f4d1-4c2f-83f7-8a9b9cca29ae"/>
    <ds:schemaRef ds:uri="http://www.w3.org/XML/1998/namespace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D65AF545-1486-4AF9-B90A-3B2701D98276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3AB88CCB-DDC1-4070-A8B1-8D3A2BDB898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dcca6e4b-f4d1-4c2f-83f7-8a9b9cca29ae"/>
    <ds:schemaRef ds:uri="220f49fd-4060-4647-a9a5-4c9032b44770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29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n Meyers</dc:creator>
  <cp:lastModifiedBy>Ann Meyers</cp:lastModifiedBy>
  <cp:revision>1</cp:revision>
  <dcterms:created xsi:type="dcterms:W3CDTF">2020-02-03T10:36:19Z</dcterms:created>
  <dcterms:modified xsi:type="dcterms:W3CDTF">2020-02-24T07:12:5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FA2F3BAF291F44B9BAC9868B50C80F1</vt:lpwstr>
  </property>
</Properties>
</file>